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81" r:id="rId2"/>
  </p:sldIdLst>
  <p:sldSz cx="9144000" cy="6858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  <p:ext uri="{2D200454-40CA-4A62-9FC3-DE9A4176ACB9}">
      <p15:notesGuideLst xmlns=""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reeman, Zachary" initials="FZ" lastIdx="6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  <a:srgbClr val="00FF00"/>
    <a:srgbClr val="CC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513" autoAdjust="0"/>
    <p:restoredTop sz="69903" autoAdjust="0"/>
  </p:normalViewPr>
  <p:slideViewPr>
    <p:cSldViewPr snapToGrid="0">
      <p:cViewPr>
        <p:scale>
          <a:sx n="160" d="100"/>
          <a:sy n="160" d="100"/>
        </p:scale>
        <p:origin x="-252" y="236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73" d="100"/>
          <a:sy n="73" d="100"/>
        </p:scale>
        <p:origin x="2262" y="8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41968" cy="467451"/>
          </a:xfrm>
          <a:prstGeom prst="rect">
            <a:avLst/>
          </a:prstGeom>
        </p:spPr>
        <p:txBody>
          <a:bodyPr vert="horz" lIns="93279" tIns="46641" rIns="93279" bIns="4664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6740" y="1"/>
            <a:ext cx="3041968" cy="467451"/>
          </a:xfrm>
          <a:prstGeom prst="rect">
            <a:avLst/>
          </a:prstGeom>
        </p:spPr>
        <p:txBody>
          <a:bodyPr vert="horz" lIns="93279" tIns="46641" rIns="93279" bIns="46641" rtlCol="0"/>
          <a:lstStyle>
            <a:lvl1pPr algn="r">
              <a:defRPr sz="1200"/>
            </a:lvl1pPr>
          </a:lstStyle>
          <a:p>
            <a:fld id="{DBD3558C-0035-48B5-AB58-788A86F55A4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38476"/>
            <a:ext cx="3041968" cy="467450"/>
          </a:xfrm>
          <a:prstGeom prst="rect">
            <a:avLst/>
          </a:prstGeom>
        </p:spPr>
        <p:txBody>
          <a:bodyPr vert="horz" lIns="93279" tIns="46641" rIns="93279" bIns="4664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6740" y="8838476"/>
            <a:ext cx="3041968" cy="467450"/>
          </a:xfrm>
          <a:prstGeom prst="rect">
            <a:avLst/>
          </a:prstGeom>
        </p:spPr>
        <p:txBody>
          <a:bodyPr vert="horz" lIns="93279" tIns="46641" rIns="93279" bIns="46641" rtlCol="0" anchor="b"/>
          <a:lstStyle>
            <a:lvl1pPr algn="r">
              <a:defRPr sz="1200"/>
            </a:lvl1pPr>
          </a:lstStyle>
          <a:p>
            <a:fld id="{B777CC2A-ED66-41CA-8D7C-0DED167903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32909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41968" cy="466912"/>
          </a:xfrm>
          <a:prstGeom prst="rect">
            <a:avLst/>
          </a:prstGeom>
        </p:spPr>
        <p:txBody>
          <a:bodyPr vert="horz" lIns="93279" tIns="46641" rIns="93279" bIns="4664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4" y="1"/>
            <a:ext cx="3041968" cy="466912"/>
          </a:xfrm>
          <a:prstGeom prst="rect">
            <a:avLst/>
          </a:prstGeom>
        </p:spPr>
        <p:txBody>
          <a:bodyPr vert="horz" lIns="93279" tIns="46641" rIns="93279" bIns="46641" rtlCol="0"/>
          <a:lstStyle>
            <a:lvl1pPr algn="r">
              <a:defRPr sz="1200"/>
            </a:lvl1pPr>
          </a:lstStyle>
          <a:p>
            <a:fld id="{58E5CAB3-8DA8-4612-9FB4-C043D70D76FF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6050" y="1163638"/>
            <a:ext cx="4187825" cy="3140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79" tIns="46641" rIns="93279" bIns="4664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78477"/>
            <a:ext cx="5615940" cy="3664209"/>
          </a:xfrm>
          <a:prstGeom prst="rect">
            <a:avLst/>
          </a:prstGeom>
        </p:spPr>
        <p:txBody>
          <a:bodyPr vert="horz" lIns="93279" tIns="46641" rIns="93279" bIns="46641" rtlCol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5"/>
            <a:ext cx="3041968" cy="466911"/>
          </a:xfrm>
          <a:prstGeom prst="rect">
            <a:avLst/>
          </a:prstGeom>
        </p:spPr>
        <p:txBody>
          <a:bodyPr vert="horz" lIns="93279" tIns="46641" rIns="93279" bIns="4664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4" y="8839015"/>
            <a:ext cx="3041968" cy="466911"/>
          </a:xfrm>
          <a:prstGeom prst="rect">
            <a:avLst/>
          </a:prstGeom>
        </p:spPr>
        <p:txBody>
          <a:bodyPr vert="horz" lIns="93279" tIns="46641" rIns="93279" bIns="46641" rtlCol="0" anchor="b"/>
          <a:lstStyle>
            <a:lvl1pPr algn="r">
              <a:defRPr sz="1200"/>
            </a:lvl1pPr>
          </a:lstStyle>
          <a:p>
            <a:fld id="{B9F49ED3-0D8E-400C-AB96-46AED96312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28644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416050" y="1163638"/>
            <a:ext cx="4187825" cy="31400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mtClean="0"/>
              <a:t>Table S1</a:t>
            </a:r>
            <a:r>
              <a:rPr lang="en-US" dirty="0"/>
              <a:t>. List of inhibitors</a:t>
            </a:r>
            <a:r>
              <a:rPr lang="en-US" baseline="0" dirty="0"/>
              <a:t> used to target epigenetic modifiers. The major classes of epigenetic modulators are abbreviated MT = methyltransferase; PAD = protein arginine deiminase; BRD = </a:t>
            </a:r>
            <a:r>
              <a:rPr lang="en-US" baseline="0" dirty="0" err="1"/>
              <a:t>bromodomain</a:t>
            </a:r>
            <a:r>
              <a:rPr lang="en-US" baseline="0" dirty="0"/>
              <a:t>; HDAC = Histone deacetylase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F49ED3-0D8E-400C-AB96-46AED96312B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0885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567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114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0970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953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401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2922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851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3503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8318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1027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85606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7589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5308320"/>
              </p:ext>
            </p:extLst>
          </p:nvPr>
        </p:nvGraphicFramePr>
        <p:xfrm>
          <a:off x="1406525" y="1411388"/>
          <a:ext cx="6087766" cy="36652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043883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3043883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</a:tblGrid>
              <a:tr h="274320">
                <a:tc>
                  <a:txBody>
                    <a:bodyPr/>
                    <a:lstStyle/>
                    <a:p>
                      <a:r>
                        <a:rPr lang="en-US" sz="1400" dirty="0"/>
                        <a:t>Drug Nam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Inhibitory Targets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r>
                        <a:rPr lang="en-US" sz="1100" dirty="0"/>
                        <a:t>GSK 591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T PRMT5 </a:t>
                      </a:r>
                      <a:endParaRPr lang="en-US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r>
                        <a:rPr lang="en-US" sz="1100" dirty="0"/>
                        <a:t>GSK484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AD PAD4 </a:t>
                      </a:r>
                      <a:endParaRPr lang="en-US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r>
                        <a:rPr lang="en-US" sz="1100" dirty="0"/>
                        <a:t>MS049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T PRMT4/6 </a:t>
                      </a:r>
                      <a:endParaRPr lang="en-US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r>
                        <a:rPr lang="en-US" sz="1100" dirty="0"/>
                        <a:t>SGC</a:t>
                      </a:r>
                      <a:r>
                        <a:rPr lang="en-US" sz="1100" baseline="0" dirty="0"/>
                        <a:t> 707</a:t>
                      </a:r>
                      <a:endParaRPr lang="en-US" sz="11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T PRMT3 </a:t>
                      </a:r>
                      <a:endParaRPr lang="en-US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r>
                        <a:rPr lang="en-US" sz="1100" dirty="0"/>
                        <a:t>GSK343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T EZH2/H1 </a:t>
                      </a:r>
                      <a:endParaRPr lang="en-US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r>
                        <a:rPr lang="en-US" sz="1100" dirty="0"/>
                        <a:t>Lly-507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T SMYD2</a:t>
                      </a:r>
                      <a:endParaRPr lang="en-US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r>
                        <a:rPr lang="en-US" sz="1100" dirty="0"/>
                        <a:t>A-196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T SUV420H1/H2</a:t>
                      </a:r>
                      <a:endParaRPr lang="en-US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r>
                        <a:rPr lang="en-US" sz="1100" dirty="0"/>
                        <a:t>JQ1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BRD BET Family 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r>
                        <a:rPr lang="en-US" sz="1100" dirty="0"/>
                        <a:t>NVS-1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RD CECR2 </a:t>
                      </a:r>
                      <a:endParaRPr lang="en-US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r>
                        <a:rPr lang="en-US" sz="1100" dirty="0"/>
                        <a:t>LP-99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RD BRD9/7 </a:t>
                      </a:r>
                      <a:endParaRPr lang="en-US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r>
                        <a:rPr lang="en-US" sz="1100" dirty="0" err="1"/>
                        <a:t>Entinostat</a:t>
                      </a:r>
                      <a:endParaRPr lang="en-US" sz="11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HDAC (Class I HDAC1 and HDAC3)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r>
                        <a:rPr lang="en-US" sz="1100" dirty="0"/>
                        <a:t>5-Azacytidin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MT </a:t>
                      </a:r>
                      <a:r>
                        <a:rPr lang="en-US" sz="1400" dirty="0" err="1"/>
                        <a:t>DNMTi</a:t>
                      </a:r>
                      <a:endParaRPr lang="en-US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-25478" y="6573731"/>
            <a:ext cx="39794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Table 1. Mao et. al. </a:t>
            </a:r>
          </a:p>
        </p:txBody>
      </p:sp>
    </p:spTree>
    <p:extLst>
      <p:ext uri="{BB962C8B-B14F-4D97-AF65-F5344CB8AC3E}">
        <p14:creationId xmlns:p14="http://schemas.microsoft.com/office/powerpoint/2010/main" val="21464729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015</TotalTime>
  <Words>97</Words>
  <Application>Microsoft Office PowerPoint</Application>
  <PresentationFormat>On-screen Show (4:3)</PresentationFormat>
  <Paragraphs>2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olumbia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per Figures</dc:title>
  <dc:creator>Mao, Wendy</dc:creator>
  <cp:lastModifiedBy>USER</cp:lastModifiedBy>
  <cp:revision>253</cp:revision>
  <cp:lastPrinted>2019-02-04T21:11:13Z</cp:lastPrinted>
  <dcterms:created xsi:type="dcterms:W3CDTF">2018-06-19T14:49:33Z</dcterms:created>
  <dcterms:modified xsi:type="dcterms:W3CDTF">2019-10-08T02:56:36Z</dcterms:modified>
</cp:coreProperties>
</file>